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74B2882-7BBB-4235-A828-EE3D98C62A3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26"/>
          <a:stretch/>
        </p:blipFill>
        <p:spPr bwMode="auto">
          <a:xfrm>
            <a:off x="603947" y="133581"/>
            <a:ext cx="5650104" cy="285827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3219E05-3970-488D-8252-D91F6E12E70E}"/>
              </a:ext>
            </a:extLst>
          </p:cNvPr>
          <p:cNvSpPr/>
          <p:nvPr/>
        </p:nvSpPr>
        <p:spPr>
          <a:xfrm>
            <a:off x="0" y="2991853"/>
            <a:ext cx="68579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563"/>
              </a:spcAft>
            </a:pPr>
            <a:r>
              <a:rPr lang="en-GB" sz="12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equency of CRISPR/Cas9-induced mutations in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rations across the target genes (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CslF3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CslF6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CslF9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vCslH1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Asterisk (0*) represents a mutation with identical number of insertions and deletions found on T1 genotypes. Black columns represent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nes, hatched columns represent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nes, and grey columns represent T</a:t>
            </a:r>
            <a:r>
              <a:rPr lang="en-GB" sz="1200" baseline="-250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nes. 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975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2:52Z</dcterms:modified>
</cp:coreProperties>
</file>